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2" y="-3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CCC55B-39E7-48CB-9E0E-DC5B8294AA21}" type="datetimeFigureOut">
              <a:rPr lang="en-US" smtClean="0"/>
              <a:pPr/>
              <a:t>2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724807-DCB5-417E-9FD4-BD24100DED0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73211" y="1295400"/>
            <a:ext cx="6477000" cy="4046041"/>
            <a:chOff x="838200" y="609600"/>
            <a:chExt cx="6477000" cy="4046041"/>
          </a:xfrm>
        </p:grpSpPr>
        <p:sp>
          <p:nvSpPr>
            <p:cNvPr id="4" name="TextBox 3"/>
            <p:cNvSpPr txBox="1"/>
            <p:nvPr/>
          </p:nvSpPr>
          <p:spPr>
            <a:xfrm>
              <a:off x="838200" y="609600"/>
              <a:ext cx="9071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ble S1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447800" y="3886200"/>
              <a:ext cx="5867400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-lowering activity and anti-aggregation activity of the 8 lead compounds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Data presented for Ab-lowering is based on 100uM testing compound in primary neurons derived from Tg2576 mice and anti-aggregation is based on equal molar ratio of compound and Ab (see material and methods for experiment details).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2515604"/>
              </p:ext>
            </p:extLst>
          </p:nvPr>
        </p:nvGraphicFramePr>
        <p:xfrm>
          <a:off x="1667852" y="2209800"/>
          <a:ext cx="5418748" cy="2209804"/>
        </p:xfrm>
        <a:graphic>
          <a:graphicData uri="http://schemas.openxmlformats.org/drawingml/2006/table">
            <a:tbl>
              <a:tblPr/>
              <a:tblGrid>
                <a:gridCol w="812812"/>
                <a:gridCol w="1507089"/>
                <a:gridCol w="1524023"/>
                <a:gridCol w="1574824"/>
              </a:tblGrid>
              <a:tr h="4525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l-G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4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l-G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4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l-G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rega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524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 of inhibition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 of inhibition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 of inhibition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2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9±1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7±3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2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3±0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3±3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2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0±2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7±7.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2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9±3.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4±9.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2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7±3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8±5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2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±4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5±3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2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8±0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5±1.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2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9±3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6±2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104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cahn School of Medicine at Mount Sina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angj08</dc:creator>
  <cp:lastModifiedBy>students</cp:lastModifiedBy>
  <cp:revision>12</cp:revision>
  <dcterms:created xsi:type="dcterms:W3CDTF">2013-12-05T21:03:27Z</dcterms:created>
  <dcterms:modified xsi:type="dcterms:W3CDTF">2014-02-28T20:17:40Z</dcterms:modified>
</cp:coreProperties>
</file>